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  <p:sldId id="256" r:id="rId4"/>
    <p:sldId id="258" r:id="rId5"/>
    <p:sldId id="259" r:id="rId6"/>
    <p:sldId id="260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8" d="100"/>
          <a:sy n="98" d="100"/>
        </p:scale>
        <p:origin x="102" y="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E1EBD5-DC88-48A3-A074-A36A22E49D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E64309C-2787-4F47-95F0-D794C62F9B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1A83CC-93FA-4995-A105-E69A1270DC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1975-57AB-4894-94DF-777BF008F06A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6A8656-42D9-4535-AA2F-A0A65C5C7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44DDC5-5D54-4DAB-9121-A3D4B462A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F273D-C05F-4069-951C-88981DB29B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057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2C6F1D-5671-4B86-9375-0AC5C1A294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31C635-4E49-472E-BDF2-ABB80DCF13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27CDA8-60DC-4163-840B-AD199ABF6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1975-57AB-4894-94DF-777BF008F06A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C439F2-F66E-4E55-BC39-3ED1FD26EF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51B89C-ABF9-455D-88A8-1B9E51DCA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F273D-C05F-4069-951C-88981DB29B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673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992E822-8DB0-467B-A4B4-B1699734BD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5625DF-BEF9-48DB-A9E9-7B5EA4323B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C9B778-5AFB-4D8F-AEF5-B3696B909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1975-57AB-4894-94DF-777BF008F06A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217930-1A4A-499F-A958-F3CE48C66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363E76-529D-43A1-945B-39F3D72E5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F273D-C05F-4069-951C-88981DB29B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718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17F423-CDD5-40A2-8CB1-BACBE27219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92A505-966C-4B7F-976A-04F707170F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306CEB-FC4F-47EB-B3BF-439952B9B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1975-57AB-4894-94DF-777BF008F06A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E1B55F-EAA5-4724-89C5-8D67B35A56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EE2430-10AB-43C0-950E-C320121856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F273D-C05F-4069-951C-88981DB29B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4493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94614F-AE08-444A-A475-222A2AA6F7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342C24-C348-44DE-A6B8-99429D502A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48A844-D517-4A86-BD75-9E230BCDBD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1975-57AB-4894-94DF-777BF008F06A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FDB9A0-4659-4AB6-9A69-73C1E5BA96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006511-872A-4395-87B4-69D793912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F273D-C05F-4069-951C-88981DB29B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711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FCABB8-891C-4B8D-865E-057FCC171A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DAD2CC-BDF5-4EC0-A348-3C0AF223EA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F0635B-B93A-4963-8864-98662403B7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4D9112-C528-4AEE-B9E2-CD95090A0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1975-57AB-4894-94DF-777BF008F06A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227783-3813-4DB2-85B3-0E48EB01A6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1CE95D-8A11-4EB3-9F49-1FEAA92B36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F273D-C05F-4069-951C-88981DB29B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0364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1A2699-E4BD-44C8-8DBF-3A0450304F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380111-42BD-4725-A847-5E57B2CE6C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9EF199-2269-490A-A52C-77AFDBA7EA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7467F8C-301D-474A-B4D6-BE758A3ACD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536FE21-4C1C-4AB8-A353-F3579BC292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370A7B-53DB-4491-A8D2-BF034E51C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1975-57AB-4894-94DF-777BF008F06A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8046A06-0C4F-40BC-ADB2-3610E5A3B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F4DB1F9-7132-4A29-8EAA-E2C8EC2094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F273D-C05F-4069-951C-88981DB29B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364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9899D5-F245-441F-8B8F-1557E35186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2DFCD74-1F87-4B0D-B9D2-1BEF3FFF1E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1975-57AB-4894-94DF-777BF008F06A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C2441D3-D1C8-4933-9E95-34763248F0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78C5B8B-D071-460F-9595-71DD550183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F273D-C05F-4069-951C-88981DB29B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982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A08C716-602A-4163-B8ED-AECD27D33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1975-57AB-4894-94DF-777BF008F06A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C4DC2FC-032E-4AAC-BA07-05F026241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635232A-2199-43C1-8C9B-70F12BB223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F273D-C05F-4069-951C-88981DB29B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9184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944868-F243-47B9-979C-81378CBB30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2E41F9-3854-42EF-B407-19AB7AAC48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50CA69-BFA8-409B-9F45-11CAEF8A3A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D21936-3C97-43EE-9644-C4A7FCB35B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1975-57AB-4894-94DF-777BF008F06A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FA68A1-EDBD-4879-92DA-42ABB33B3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55214D-3B81-42BC-82C6-A22D9E67C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F273D-C05F-4069-951C-88981DB29B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636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E02035-B6A2-4375-855D-A4638AB46C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8B2BB6A-891F-4668-88CD-5A6090F344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4DF08D-448C-46C3-B311-289A42A52B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052FCF-78F0-45B2-9DAE-65D1715182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1975-57AB-4894-94DF-777BF008F06A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1F39FA-FB89-4AE5-AD37-D7CD5204FF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41ECAD-E05E-4D82-B221-ABA991F9A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F273D-C05F-4069-951C-88981DB29B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596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98B7AA6-1B20-435C-BBFC-C63814DB34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6E6063-E1AC-4683-8C75-4976689A1F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C364B3-10D6-4BD7-917C-9619C8BAF3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761975-57AB-4894-94DF-777BF008F06A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168BF1-FA44-48C5-9839-181753B2EA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BD4C9E-5A4D-4995-9F70-C30827FE20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1F273D-C05F-4069-951C-88981DB29B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914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D065D964-C0CB-4C38-B0E2-8D48358F3D61}"/>
              </a:ext>
            </a:extLst>
          </p:cNvPr>
          <p:cNvSpPr txBox="1"/>
          <p:nvPr/>
        </p:nvSpPr>
        <p:spPr>
          <a:xfrm>
            <a:off x="2231472" y="74429"/>
            <a:ext cx="73068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pectra of short complex glycans identified on N331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C49F05F-48F0-4489-9CF6-364DBD6B3FC7}"/>
              </a:ext>
            </a:extLst>
          </p:cNvPr>
          <p:cNvSpPr txBox="1"/>
          <p:nvPr/>
        </p:nvSpPr>
        <p:spPr>
          <a:xfrm>
            <a:off x="0" y="74429"/>
            <a:ext cx="2231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S1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9E50306-A2F9-4171-ABCD-FC813DC1BF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82570"/>
            <a:ext cx="11971986" cy="1867367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9EF89B5-5F60-4528-B5AE-0D7DEAB39D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527612"/>
            <a:ext cx="12192000" cy="218920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67F4DC2-E63A-4F2E-9BB9-255BDA46B62B}"/>
              </a:ext>
            </a:extLst>
          </p:cNvPr>
          <p:cNvSpPr txBox="1"/>
          <p:nvPr/>
        </p:nvSpPr>
        <p:spPr>
          <a:xfrm>
            <a:off x="620786" y="586994"/>
            <a:ext cx="448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9B73F8F-2CC1-49E1-AA29-C7CED5C4785C}"/>
              </a:ext>
            </a:extLst>
          </p:cNvPr>
          <p:cNvSpPr txBox="1"/>
          <p:nvPr/>
        </p:nvSpPr>
        <p:spPr>
          <a:xfrm>
            <a:off x="620786" y="3569442"/>
            <a:ext cx="448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8D5AF88-E541-4ED2-A962-94B74E7B83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08901" y="663266"/>
            <a:ext cx="9812897" cy="50580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F9C6E7F-FFA9-471F-80BB-340C3AA49F1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9444" y="3605727"/>
            <a:ext cx="9752354" cy="4629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75355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CFB5384-03DD-4007-903D-4CDB2051D1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0824" y="613986"/>
            <a:ext cx="7933503" cy="40621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17FD1A6-D1E4-418D-A249-BC270D9575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0824" y="3658983"/>
            <a:ext cx="7790891" cy="40621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065D964-C0CB-4C38-B0E2-8D48358F3D61}"/>
              </a:ext>
            </a:extLst>
          </p:cNvPr>
          <p:cNvSpPr txBox="1"/>
          <p:nvPr/>
        </p:nvSpPr>
        <p:spPr>
          <a:xfrm>
            <a:off x="2158767" y="66040"/>
            <a:ext cx="73068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523 was identified as O-</a:t>
            </a:r>
            <a:r>
              <a:rPr lang="en-US" b="1" dirty="0" err="1"/>
              <a:t>glycosite</a:t>
            </a:r>
            <a:r>
              <a:rPr lang="en-US" b="1" dirty="0"/>
              <a:t> from recombinant RBD protein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61CBC55-31A1-419B-BCC6-BA50A6173BC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1135962"/>
            <a:ext cx="12192000" cy="198442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7F5DF5A-59AC-4A2C-9BD2-D41CD946EEC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4387956"/>
            <a:ext cx="12192000" cy="212561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C49F05F-48F0-4489-9CF6-364DBD6B3FC7}"/>
              </a:ext>
            </a:extLst>
          </p:cNvPr>
          <p:cNvSpPr txBox="1"/>
          <p:nvPr/>
        </p:nvSpPr>
        <p:spPr>
          <a:xfrm>
            <a:off x="0" y="74429"/>
            <a:ext cx="2231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S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6A48828-A5ED-4C2B-A20C-DBA5DD05D6B8}"/>
              </a:ext>
            </a:extLst>
          </p:cNvPr>
          <p:cNvSpPr txBox="1"/>
          <p:nvPr/>
        </p:nvSpPr>
        <p:spPr>
          <a:xfrm>
            <a:off x="83890" y="561827"/>
            <a:ext cx="448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8031AA2-9464-4C07-B76D-0CFD2689AF43}"/>
              </a:ext>
            </a:extLst>
          </p:cNvPr>
          <p:cNvSpPr txBox="1"/>
          <p:nvPr/>
        </p:nvSpPr>
        <p:spPr>
          <a:xfrm>
            <a:off x="83890" y="3658983"/>
            <a:ext cx="448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3498202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0BC825A-4D99-4DCA-8490-88591EC0EF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52983"/>
            <a:ext cx="12192000" cy="220890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7D21165-72EB-4DB8-B892-CEDD292C90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6163" y="605143"/>
            <a:ext cx="7541273" cy="38612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215A81D-947D-46EA-A9B0-9AE9FF1594F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6163" y="3775957"/>
            <a:ext cx="7541273" cy="38612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D0EE4DD-7440-463A-B2E6-F5F1D96ACA6B}"/>
              </a:ext>
            </a:extLst>
          </p:cNvPr>
          <p:cNvSpPr txBox="1"/>
          <p:nvPr/>
        </p:nvSpPr>
        <p:spPr>
          <a:xfrm>
            <a:off x="-1" y="74429"/>
            <a:ext cx="37559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S2 continued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BE484CC-63BE-4AE5-96E8-10B2F32C6CA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1" y="4576155"/>
            <a:ext cx="12192000" cy="205228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CBE9524-F659-4EFF-A4C3-B02F000A541D}"/>
              </a:ext>
            </a:extLst>
          </p:cNvPr>
          <p:cNvSpPr txBox="1"/>
          <p:nvPr/>
        </p:nvSpPr>
        <p:spPr>
          <a:xfrm>
            <a:off x="83890" y="561827"/>
            <a:ext cx="448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2360A78-09B5-4034-881A-760F45FDE3A9}"/>
              </a:ext>
            </a:extLst>
          </p:cNvPr>
          <p:cNvSpPr txBox="1"/>
          <p:nvPr/>
        </p:nvSpPr>
        <p:spPr>
          <a:xfrm>
            <a:off x="83890" y="3658983"/>
            <a:ext cx="448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.</a:t>
            </a:r>
          </a:p>
        </p:txBody>
      </p:sp>
    </p:spTree>
    <p:extLst>
      <p:ext uri="{BB962C8B-B14F-4D97-AF65-F5344CB8AC3E}">
        <p14:creationId xmlns:p14="http://schemas.microsoft.com/office/powerpoint/2010/main" val="42678349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C49F05F-48F0-4489-9CF6-364DBD6B3FC7}"/>
              </a:ext>
            </a:extLst>
          </p:cNvPr>
          <p:cNvSpPr txBox="1"/>
          <p:nvPr/>
        </p:nvSpPr>
        <p:spPr>
          <a:xfrm>
            <a:off x="0" y="74429"/>
            <a:ext cx="2231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S3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6DFB41D-595D-4901-8B84-9AD727775C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6823" y="0"/>
            <a:ext cx="427835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05181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09F4916-AB4D-4B09-B973-2341332EA7AE}"/>
              </a:ext>
            </a:extLst>
          </p:cNvPr>
          <p:cNvSpPr txBox="1"/>
          <p:nvPr/>
        </p:nvSpPr>
        <p:spPr>
          <a:xfrm>
            <a:off x="159390" y="275764"/>
            <a:ext cx="2952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S4 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79D0C7A-45B0-4D0A-A136-545AC22ADE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3747" y="1135577"/>
            <a:ext cx="9284506" cy="51729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22628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09F4916-AB4D-4B09-B973-2341332EA7AE}"/>
              </a:ext>
            </a:extLst>
          </p:cNvPr>
          <p:cNvSpPr txBox="1"/>
          <p:nvPr/>
        </p:nvSpPr>
        <p:spPr>
          <a:xfrm>
            <a:off x="159389" y="275764"/>
            <a:ext cx="2592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S4 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F64E6BA-3E65-49A8-929C-AE1C05DAC1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7131" y="1165217"/>
            <a:ext cx="8754064" cy="51270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30627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6</TotalTime>
  <Words>51</Words>
  <Application>Microsoft Office PowerPoint</Application>
  <PresentationFormat>Widescreen</PresentationFormat>
  <Paragraphs>1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an, Yuan</dc:creator>
  <cp:lastModifiedBy>Cipollo, John</cp:lastModifiedBy>
  <cp:revision>22</cp:revision>
  <dcterms:created xsi:type="dcterms:W3CDTF">2021-04-06T23:32:39Z</dcterms:created>
  <dcterms:modified xsi:type="dcterms:W3CDTF">2021-10-05T14:57:29Z</dcterms:modified>
</cp:coreProperties>
</file>